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DDD4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9189" autoAdjust="0"/>
  </p:normalViewPr>
  <p:slideViewPr>
    <p:cSldViewPr snapToGrid="0" snapToObjects="1">
      <p:cViewPr varScale="1">
        <p:scale>
          <a:sx n="77" d="100"/>
          <a:sy n="77" d="100"/>
        </p:scale>
        <p:origin x="1872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edrosian%20Lab:mir140%20fluvastatin%20data:qPCR:HS#88 -  Quantification Cq Resul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mymdafiles\surg37\DOS\Surg-Onc\Bedrosian%20Lab\Harpreet\Experiments\QPCR\HS%2388%20-%20%20Quantification%20Cq%20Resul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i="1" dirty="0"/>
              <a:t>HMGCR</a:t>
            </a:r>
          </a:p>
        </c:rich>
      </c:tx>
      <c:layout>
        <c:manualLayout>
          <c:xMode val="edge"/>
          <c:yMode val="edge"/>
          <c:x val="0.44487521787421003"/>
          <c:y val="8.0657019523516005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1329711987561"/>
          <c:y val="9.1249146093696401E-2"/>
          <c:w val="0.82835106009855697"/>
          <c:h val="0.6656069753920229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V$2:$V$20</c:f>
                <c:numCache>
                  <c:formatCode>General</c:formatCode>
                  <c:ptCount val="19"/>
                  <c:pt idx="0">
                    <c:v>3.9967549289829499E-2</c:v>
                  </c:pt>
                  <c:pt idx="6">
                    <c:v>5.6296875887164597E-3</c:v>
                  </c:pt>
                  <c:pt idx="12">
                    <c:v>1.56804225413186E-2</c:v>
                  </c:pt>
                  <c:pt idx="18">
                    <c:v>3.6178905045474601E-3</c:v>
                  </c:pt>
                </c:numCache>
              </c:numRef>
            </c:plus>
            <c:minus>
              <c:numRef>
                <c:f>'0'!$V$2:$V$20</c:f>
                <c:numCache>
                  <c:formatCode>General</c:formatCode>
                  <c:ptCount val="19"/>
                  <c:pt idx="0">
                    <c:v>3.9967549289829499E-2</c:v>
                  </c:pt>
                  <c:pt idx="6">
                    <c:v>5.6296875887164597E-3</c:v>
                  </c:pt>
                  <c:pt idx="12">
                    <c:v>1.56804225413186E-2</c:v>
                  </c:pt>
                  <c:pt idx="18">
                    <c:v>3.6178905045474601E-3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0'!$AD$5:$AD$8</c:f>
              <c:strCache>
                <c:ptCount val="4"/>
                <c:pt idx="0">
                  <c:v>10A (P)</c:v>
                </c:pt>
                <c:pt idx="1">
                  <c:v>AT1</c:v>
                </c:pt>
                <c:pt idx="2">
                  <c:v>DCIS</c:v>
                </c:pt>
                <c:pt idx="3">
                  <c:v>Ca1d</c:v>
                </c:pt>
              </c:strCache>
            </c:strRef>
          </c:cat>
          <c:val>
            <c:numRef>
              <c:f>'0'!$AE$5:$AE$8</c:f>
              <c:numCache>
                <c:formatCode>General</c:formatCode>
                <c:ptCount val="4"/>
                <c:pt idx="0">
                  <c:v>1</c:v>
                </c:pt>
                <c:pt idx="1">
                  <c:v>1.5</c:v>
                </c:pt>
                <c:pt idx="2">
                  <c:v>1.7</c:v>
                </c:pt>
                <c:pt idx="3">
                  <c:v>2.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D0-4773-90A2-C20608BC9F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380957728"/>
        <c:axId val="-1496760848"/>
      </c:barChart>
      <c:catAx>
        <c:axId val="-13809577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/>
                <a:ea typeface="+mn-ea"/>
                <a:cs typeface="Arial"/>
              </a:defRPr>
            </a:pPr>
            <a:endParaRPr lang="en-US"/>
          </a:p>
        </c:txPr>
        <c:crossAx val="-1496760848"/>
        <c:crosses val="autoZero"/>
        <c:auto val="1"/>
        <c:lblAlgn val="ctr"/>
        <c:lblOffset val="100"/>
        <c:noMultiLvlLbl val="0"/>
      </c:catAx>
      <c:valAx>
        <c:axId val="-14967608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/>
                <a:ea typeface="+mn-ea"/>
                <a:cs typeface="Arial"/>
              </a:defRPr>
            </a:pPr>
            <a:endParaRPr lang="en-US"/>
          </a:p>
        </c:txPr>
        <c:crossAx val="-138095772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/>
                <a:ea typeface="+mn-ea"/>
                <a:cs typeface="Arial"/>
              </a:defRPr>
            </a:pPr>
            <a:r>
              <a:rPr lang="en-US" sz="1400" i="1" dirty="0">
                <a:latin typeface="Arial"/>
                <a:cs typeface="Arial"/>
              </a:rPr>
              <a:t>HMGCS</a:t>
            </a:r>
            <a:r>
              <a:rPr lang="en-US" sz="1400" dirty="0">
                <a:latin typeface="Arial"/>
                <a:cs typeface="Arial"/>
              </a:rPr>
              <a:t>1</a:t>
            </a:r>
          </a:p>
        </c:rich>
      </c:tx>
      <c:layout>
        <c:manualLayout>
          <c:xMode val="edge"/>
          <c:yMode val="edge"/>
          <c:x val="0.41515172331269601"/>
          <c:y val="8.17230589661809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Arial"/>
              <a:ea typeface="+mn-ea"/>
              <a:cs typeface="Arial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V$26:$V$44</c:f>
                <c:numCache>
                  <c:formatCode>General</c:formatCode>
                  <c:ptCount val="19"/>
                  <c:pt idx="0">
                    <c:v>1.7121339557195098E-2</c:v>
                  </c:pt>
                  <c:pt idx="6">
                    <c:v>2.1674018819615701E-2</c:v>
                  </c:pt>
                  <c:pt idx="12">
                    <c:v>2.6790307906729399E-2</c:v>
                  </c:pt>
                  <c:pt idx="18">
                    <c:v>1.2634922499463901E-2</c:v>
                  </c:pt>
                </c:numCache>
              </c:numRef>
            </c:plus>
            <c:minus>
              <c:numRef>
                <c:f>'0'!$V$26:$V$44</c:f>
                <c:numCache>
                  <c:formatCode>General</c:formatCode>
                  <c:ptCount val="19"/>
                  <c:pt idx="0">
                    <c:v>1.7121339557195098E-2</c:v>
                  </c:pt>
                  <c:pt idx="6">
                    <c:v>2.1674018819615701E-2</c:v>
                  </c:pt>
                  <c:pt idx="12">
                    <c:v>2.6790307906729399E-2</c:v>
                  </c:pt>
                  <c:pt idx="18">
                    <c:v>1.2634922499463901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0'!$AD$5:$AD$8</c:f>
              <c:strCache>
                <c:ptCount val="4"/>
                <c:pt idx="0">
                  <c:v>10A (P)</c:v>
                </c:pt>
                <c:pt idx="1">
                  <c:v>AT1</c:v>
                </c:pt>
                <c:pt idx="2">
                  <c:v>DCIS</c:v>
                </c:pt>
                <c:pt idx="3">
                  <c:v>Ca1d</c:v>
                </c:pt>
              </c:strCache>
            </c:strRef>
          </c:cat>
          <c:val>
            <c:numRef>
              <c:f>'0'!$AF$5:$AF$8</c:f>
              <c:numCache>
                <c:formatCode>General</c:formatCode>
                <c:ptCount val="4"/>
                <c:pt idx="0">
                  <c:v>1</c:v>
                </c:pt>
                <c:pt idx="1">
                  <c:v>3.18</c:v>
                </c:pt>
                <c:pt idx="2">
                  <c:v>2.1</c:v>
                </c:pt>
                <c:pt idx="3">
                  <c:v>5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8C-4C7B-8BB7-27279E116A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272597952"/>
        <c:axId val="-1272595632"/>
      </c:barChart>
      <c:catAx>
        <c:axId val="-12725979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/>
                <a:ea typeface="+mn-ea"/>
                <a:cs typeface="Arial"/>
              </a:defRPr>
            </a:pPr>
            <a:endParaRPr lang="en-US"/>
          </a:p>
        </c:txPr>
        <c:crossAx val="-1272595632"/>
        <c:crosses val="autoZero"/>
        <c:auto val="1"/>
        <c:lblAlgn val="ctr"/>
        <c:lblOffset val="100"/>
        <c:noMultiLvlLbl val="0"/>
      </c:catAx>
      <c:valAx>
        <c:axId val="-12725956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2725979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107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 mods="ignoreCSTransforms">
      <cs:styleClr val="0">
        <a:shade val="25000"/>
      </cs:styl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 mods="ignoreCSTransforms">
      <cs:styleClr val="0">
        <a:tint val="25000"/>
      </cs:styl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106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 mods="ignoreCSTransforms">
      <cs:styleClr val="0">
        <a:shade val="25000"/>
      </cs:styl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 mods="ignoreCSTransforms">
      <cs:styleClr val="0">
        <a:tint val="25000"/>
      </cs:styl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CE0F4E-AF84-C041-8DD5-F7C110A97E6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7917B1-6A11-504A-8FF5-59500827B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21064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5428BC-AF00-184B-BCFD-6E972B9CA406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538EA5-A10F-C241-BEA0-1187843888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8459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830FA-8C33-D24C-B1A9-562F11AD79F4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8E12B-98B7-DE4F-84BA-7E4F62A024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683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830FA-8C33-D24C-B1A9-562F11AD79F4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8E12B-98B7-DE4F-84BA-7E4F62A024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804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830FA-8C33-D24C-B1A9-562F11AD79F4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8E12B-98B7-DE4F-84BA-7E4F62A024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683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830FA-8C33-D24C-B1A9-562F11AD79F4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8E12B-98B7-DE4F-84BA-7E4F62A024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084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830FA-8C33-D24C-B1A9-562F11AD79F4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8E12B-98B7-DE4F-84BA-7E4F62A024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267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830FA-8C33-D24C-B1A9-562F11AD79F4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8E12B-98B7-DE4F-84BA-7E4F62A024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803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830FA-8C33-D24C-B1A9-562F11AD79F4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8E12B-98B7-DE4F-84BA-7E4F62A024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357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830FA-8C33-D24C-B1A9-562F11AD79F4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8E12B-98B7-DE4F-84BA-7E4F62A024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378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830FA-8C33-D24C-B1A9-562F11AD79F4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8E12B-98B7-DE4F-84BA-7E4F62A024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653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830FA-8C33-D24C-B1A9-562F11AD79F4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8E12B-98B7-DE4F-84BA-7E4F62A024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211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830FA-8C33-D24C-B1A9-562F11AD79F4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8E12B-98B7-DE4F-84BA-7E4F62A024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282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F830FA-8C33-D24C-B1A9-562F11AD79F4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8E12B-98B7-DE4F-84BA-7E4F62A024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696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194"/>
          <p:cNvSpPr txBox="1">
            <a:spLocks noChangeArrowheads="1"/>
          </p:cNvSpPr>
          <p:nvPr/>
        </p:nvSpPr>
        <p:spPr bwMode="auto">
          <a:xfrm>
            <a:off x="113822" y="471843"/>
            <a:ext cx="391121" cy="321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04769" tIns="52385" rIns="104769" bIns="52385">
            <a:spAutoFit/>
          </a:bodyPr>
          <a:lstStyle>
            <a:lvl1pPr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r>
              <a:rPr lang="en-US" altLang="en-US" sz="1400" b="1" dirty="0">
                <a:latin typeface="Arial"/>
                <a:cs typeface="Arial"/>
              </a:rPr>
              <a:t>A.</a:t>
            </a:r>
          </a:p>
        </p:txBody>
      </p:sp>
      <p:sp>
        <p:nvSpPr>
          <p:cNvPr id="10" name="TextBox 195"/>
          <p:cNvSpPr txBox="1">
            <a:spLocks noChangeArrowheads="1"/>
          </p:cNvSpPr>
          <p:nvPr/>
        </p:nvSpPr>
        <p:spPr bwMode="auto">
          <a:xfrm>
            <a:off x="3607374" y="471843"/>
            <a:ext cx="391121" cy="321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04769" tIns="52385" rIns="104769" bIns="52385">
            <a:spAutoFit/>
          </a:bodyPr>
          <a:lstStyle>
            <a:lvl1pPr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r>
              <a:rPr lang="en-US" altLang="en-US" sz="1400" b="1" dirty="0">
                <a:latin typeface="Arial"/>
                <a:cs typeface="Arial"/>
              </a:rPr>
              <a:t>B.</a:t>
            </a:r>
          </a:p>
        </p:txBody>
      </p:sp>
      <p:sp>
        <p:nvSpPr>
          <p:cNvPr id="11" name="CustomShape 2"/>
          <p:cNvSpPr/>
          <p:nvPr/>
        </p:nvSpPr>
        <p:spPr>
          <a:xfrm>
            <a:off x="1010388" y="978668"/>
            <a:ext cx="2182458" cy="502473"/>
          </a:xfrm>
          <a:prstGeom prst="rect">
            <a:avLst/>
          </a:prstGeom>
          <a:solidFill>
            <a:srgbClr val="D9D9D9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88393" tIns="44196" rIns="88393" bIns="44196" anchor="ctr"/>
          <a:lstStyle/>
          <a:p>
            <a:pPr algn="ctr">
              <a:lnSpc>
                <a:spcPct val="100000"/>
              </a:lnSpc>
            </a:pPr>
            <a:r>
              <a:rPr lang="en-US" sz="982" dirty="0">
                <a:solidFill>
                  <a:srgbClr val="000000"/>
                </a:solidFill>
                <a:latin typeface="Arial"/>
                <a:cs typeface="Arial"/>
              </a:rPr>
              <a:t>Identified miRNA and mRNA deregulations in normal to DCIS, t test, p&lt;0.05</a:t>
            </a:r>
            <a:endParaRPr sz="982" dirty="0">
              <a:latin typeface="Arial"/>
              <a:cs typeface="Arial"/>
            </a:endParaRPr>
          </a:p>
        </p:txBody>
      </p:sp>
      <p:sp>
        <p:nvSpPr>
          <p:cNvPr id="12" name="CustomShape 3"/>
          <p:cNvSpPr/>
          <p:nvPr/>
        </p:nvSpPr>
        <p:spPr>
          <a:xfrm>
            <a:off x="982446" y="1564973"/>
            <a:ext cx="2223176" cy="758408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rgbClr val="000000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lIns="88393" tIns="44196" rIns="88393" bIns="44196" anchor="ctr"/>
          <a:lstStyle/>
          <a:p>
            <a:pPr algn="ctr">
              <a:lnSpc>
                <a:spcPct val="100000"/>
              </a:lnSpc>
            </a:pPr>
            <a:r>
              <a:rPr lang="en-US" sz="982" dirty="0">
                <a:solidFill>
                  <a:srgbClr val="000000"/>
                </a:solidFill>
                <a:latin typeface="Arial"/>
                <a:cs typeface="Arial"/>
              </a:rPr>
              <a:t>Integrated gene targets of miR-140-3p-1 (interaction predicted by Target Scan, inverse directionality, FDR &lt;0.25) in normal to DCIS</a:t>
            </a:r>
            <a:endParaRPr sz="982" dirty="0">
              <a:latin typeface="Arial"/>
              <a:cs typeface="Arial"/>
            </a:endParaRPr>
          </a:p>
        </p:txBody>
      </p:sp>
      <p:sp>
        <p:nvSpPr>
          <p:cNvPr id="13" name="CustomShape 5"/>
          <p:cNvSpPr/>
          <p:nvPr/>
        </p:nvSpPr>
        <p:spPr>
          <a:xfrm>
            <a:off x="985612" y="2389231"/>
            <a:ext cx="2223179" cy="50400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88393" tIns="44196" rIns="88393" bIns="44196" anchor="ctr"/>
          <a:lstStyle/>
          <a:p>
            <a:pPr algn="ctr"/>
            <a:r>
              <a:rPr lang="en-US" sz="982" dirty="0">
                <a:latin typeface="Arial"/>
                <a:cs typeface="Arial"/>
              </a:rPr>
              <a:t>10 genes possess a significant and negative correlation (r &lt; -0.45 and p value &lt; 0.1)</a:t>
            </a:r>
          </a:p>
        </p:txBody>
      </p:sp>
      <p:sp>
        <p:nvSpPr>
          <p:cNvPr id="14" name="CustomShape 3"/>
          <p:cNvSpPr/>
          <p:nvPr/>
        </p:nvSpPr>
        <p:spPr>
          <a:xfrm>
            <a:off x="973079" y="2956559"/>
            <a:ext cx="2228862" cy="590060"/>
          </a:xfrm>
          <a:prstGeom prst="rect">
            <a:avLst/>
          </a:prstGeom>
          <a:solidFill>
            <a:srgbClr val="CCC1DA"/>
          </a:solidFill>
          <a:ln>
            <a:solidFill>
              <a:srgbClr val="000000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lIns="88393" tIns="44196" rIns="88393" bIns="44196" anchor="ctr"/>
          <a:lstStyle/>
          <a:p>
            <a:pPr algn="ctr">
              <a:lnSpc>
                <a:spcPct val="100000"/>
              </a:lnSpc>
            </a:pPr>
            <a:r>
              <a:rPr lang="en-US" sz="982" dirty="0">
                <a:latin typeface="Arial"/>
                <a:cs typeface="Arial"/>
              </a:rPr>
              <a:t>All 10 gene targets taken to next level of pathway involvement as predicted by IPA</a:t>
            </a:r>
            <a:endParaRPr sz="982" dirty="0">
              <a:latin typeface="Arial"/>
              <a:cs typeface="Arial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1208818" y="321063"/>
            <a:ext cx="1805871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82" b="1" dirty="0">
                <a:latin typeface="Arial"/>
                <a:cs typeface="Arial"/>
              </a:rPr>
              <a:t>Set of filters  to extract the most significantly </a:t>
            </a:r>
          </a:p>
          <a:p>
            <a:pPr algn="ctr"/>
            <a:r>
              <a:rPr lang="en-US" sz="982" b="1" dirty="0">
                <a:latin typeface="Arial"/>
                <a:cs typeface="Arial"/>
              </a:rPr>
              <a:t>altered (normal to DCIS), gene targets  </a:t>
            </a:r>
            <a:endParaRPr lang="en-US" sz="982" dirty="0">
              <a:latin typeface="Arial"/>
              <a:cs typeface="Arial"/>
            </a:endParaRPr>
          </a:p>
        </p:txBody>
      </p:sp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2999980"/>
              </p:ext>
            </p:extLst>
          </p:nvPr>
        </p:nvGraphicFramePr>
        <p:xfrm>
          <a:off x="3521965" y="583202"/>
          <a:ext cx="4169411" cy="2740476"/>
        </p:xfrm>
        <a:graphic>
          <a:graphicData uri="http://schemas.openxmlformats.org/drawingml/2006/table">
            <a:tbl>
              <a:tblPr/>
              <a:tblGrid>
                <a:gridCol w="281546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5394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696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effectLst/>
                          <a:latin typeface="Arial"/>
                        </a:rPr>
                        <a:t>Ingenuity Canonical Pathways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  <a:p>
                      <a:pPr algn="l" fontAlgn="b"/>
                      <a:r>
                        <a:rPr lang="en-US" sz="1000" b="1" i="0" u="none" strike="noStrike" dirty="0">
                          <a:effectLst/>
                          <a:latin typeface="Arial"/>
                        </a:rPr>
                        <a:t>Molecules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48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Mevalonate Pathway I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MGCR, HMGCS1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72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effectLst/>
                          <a:latin typeface="Arial"/>
                        </a:rPr>
                        <a:t>Superpathway</a:t>
                      </a:r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 of </a:t>
                      </a:r>
                      <a:r>
                        <a:rPr lang="en-US" sz="1000" b="0" i="0" u="none" strike="noStrike" dirty="0" err="1">
                          <a:effectLst/>
                          <a:latin typeface="Arial"/>
                        </a:rPr>
                        <a:t>Geranylgeranyldiphosphate</a:t>
                      </a:r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 Biosynthesis I (via </a:t>
                      </a:r>
                      <a:r>
                        <a:rPr lang="en-US" sz="1000" b="0" i="0" u="none" strike="noStrike" dirty="0" err="1">
                          <a:effectLst/>
                          <a:latin typeface="Arial"/>
                        </a:rPr>
                        <a:t>Mevalonate</a:t>
                      </a:r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)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MGCR, HMGCS1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48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effectLst/>
                          <a:latin typeface="Arial"/>
                        </a:rPr>
                        <a:t>Superpathway</a:t>
                      </a:r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 of Cholesterol Biosynthesis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MGCR, HMGCS1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48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LPS/IL-1 Mediated Inhibition of RXR Function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PPARGC1B, HMGCS1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48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Ketogenesis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MGCS1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72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Transcriptional Regulatory Network in Embryonic Stem Cells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GATA6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48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Assembly of RNA Polymerase II Complex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TAF4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172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Role of NANOG in Mammalian Embryonic Stem Cell </a:t>
                      </a:r>
                      <a:r>
                        <a:rPr lang="en-US" sz="1000" b="0" i="0" u="none" strike="noStrike" dirty="0" err="1">
                          <a:effectLst/>
                          <a:latin typeface="Arial"/>
                        </a:rPr>
                        <a:t>Pluripotency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GATA6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48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LXR/RXR Activation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MGCR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48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Estrogen Receptor Signaling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TAF4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48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AMPK Signaling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MGCR</a:t>
                      </a:r>
                    </a:p>
                  </a:txBody>
                  <a:tcPr marL="12473" marR="12473" marT="124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17" name="TextBox 195"/>
          <p:cNvSpPr txBox="1">
            <a:spLocks noChangeArrowheads="1"/>
          </p:cNvSpPr>
          <p:nvPr/>
        </p:nvSpPr>
        <p:spPr bwMode="auto">
          <a:xfrm>
            <a:off x="230426" y="3644441"/>
            <a:ext cx="391121" cy="321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04769" tIns="52385" rIns="104769" bIns="52385">
            <a:spAutoFit/>
          </a:bodyPr>
          <a:lstStyle>
            <a:lvl1pPr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r>
              <a:rPr lang="en-US" altLang="en-US" sz="1400" b="1" dirty="0">
                <a:latin typeface="Arial"/>
                <a:cs typeface="Arial"/>
              </a:rPr>
              <a:t>C.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0" y="-52701"/>
            <a:ext cx="1277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. 2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935759" y="5655474"/>
            <a:ext cx="72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*p&lt;0.05</a:t>
            </a:r>
          </a:p>
        </p:txBody>
      </p:sp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3862100"/>
              </p:ext>
            </p:extLst>
          </p:nvPr>
        </p:nvGraphicFramePr>
        <p:xfrm>
          <a:off x="782270" y="3794715"/>
          <a:ext cx="3020665" cy="21884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5" name="TextBox 24"/>
          <p:cNvSpPr txBox="1"/>
          <p:nvPr/>
        </p:nvSpPr>
        <p:spPr>
          <a:xfrm rot="16200000">
            <a:off x="-92989" y="4544542"/>
            <a:ext cx="15897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mRNA levels (Fold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156034" y="4009512"/>
            <a:ext cx="204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907102" y="4459653"/>
            <a:ext cx="204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532295" y="4369962"/>
            <a:ext cx="204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701677" y="3665122"/>
            <a:ext cx="3427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D.</a:t>
            </a:r>
            <a:endParaRPr lang="en-US" sz="1400" b="1" dirty="0"/>
          </a:p>
        </p:txBody>
      </p:sp>
      <p:graphicFrame>
        <p:nvGraphicFramePr>
          <p:cNvPr id="30" name="Char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6013975"/>
              </p:ext>
            </p:extLst>
          </p:nvPr>
        </p:nvGraphicFramePr>
        <p:xfrm>
          <a:off x="4518236" y="3794715"/>
          <a:ext cx="3671684" cy="21884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1" name="TextBox 30"/>
          <p:cNvSpPr txBox="1"/>
          <p:nvPr/>
        </p:nvSpPr>
        <p:spPr>
          <a:xfrm rot="16200000">
            <a:off x="3521492" y="4523120"/>
            <a:ext cx="1570086" cy="455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2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179" dirty="0">
                <a:latin typeface="Arial"/>
                <a:cs typeface="Arial"/>
              </a:rPr>
              <a:t>mRNA expression (fold)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5893066" y="4474342"/>
            <a:ext cx="204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693154" y="4779903"/>
            <a:ext cx="204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488288" y="3821148"/>
            <a:ext cx="204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39037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413</TotalTime>
  <Words>194</Words>
  <Application>Microsoft Office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MS PGothic</vt:lpstr>
      <vt:lpstr>Arial</vt:lpstr>
      <vt:lpstr>Calibri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njana</dc:creator>
  <cp:keywords/>
  <dc:description/>
  <cp:lastModifiedBy>Bhardwaj,Anjana</cp:lastModifiedBy>
  <cp:revision>529</cp:revision>
  <cp:lastPrinted>2018-08-31T19:59:20Z</cp:lastPrinted>
  <dcterms:created xsi:type="dcterms:W3CDTF">2017-04-13T15:28:02Z</dcterms:created>
  <dcterms:modified xsi:type="dcterms:W3CDTF">2018-11-23T22:15:45Z</dcterms:modified>
  <cp:category/>
</cp:coreProperties>
</file>